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674" r:id="rId2"/>
  </p:sldIdLst>
  <p:sldSz cx="4572000" cy="9326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02" userDrawn="1">
          <p15:clr>
            <a:srgbClr val="A4A3A4"/>
          </p15:clr>
        </p15:guide>
        <p15:guide id="2" pos="1392" userDrawn="1">
          <p15:clr>
            <a:srgbClr val="A4A3A4"/>
          </p15:clr>
        </p15:guide>
        <p15:guide id="3" orient="horz" pos="2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66666"/>
    <a:srgbClr val="999999"/>
    <a:srgbClr val="CCCCCC"/>
    <a:srgbClr val="396A50"/>
    <a:srgbClr val="969696"/>
    <a:srgbClr val="560000"/>
    <a:srgbClr val="5499C7"/>
    <a:srgbClr val="707070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212" autoAdjust="0"/>
    <p:restoredTop sz="94386" autoAdjust="0"/>
  </p:normalViewPr>
  <p:slideViewPr>
    <p:cSldViewPr snapToGrid="0">
      <p:cViewPr>
        <p:scale>
          <a:sx n="150" d="100"/>
          <a:sy n="150" d="100"/>
        </p:scale>
        <p:origin x="2742" y="-3504"/>
      </p:cViewPr>
      <p:guideLst>
        <p:guide orient="horz" pos="1402"/>
        <p:guide pos="1392"/>
        <p:guide orient="horz" pos="2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526362"/>
            <a:ext cx="3886200" cy="3247026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4898605"/>
            <a:ext cx="3429000" cy="2251760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21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89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8" y="496553"/>
            <a:ext cx="985838" cy="7903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496553"/>
            <a:ext cx="2900363" cy="7903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922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015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2325167"/>
            <a:ext cx="3943350" cy="3879590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6241460"/>
            <a:ext cx="3943350" cy="2040185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48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496555"/>
            <a:ext cx="3943350" cy="1802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2286304"/>
            <a:ext cx="1934170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3406786"/>
            <a:ext cx="1934170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2286304"/>
            <a:ext cx="1943696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3406786"/>
            <a:ext cx="1943696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47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8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1342854"/>
            <a:ext cx="2314575" cy="6627905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75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1342854"/>
            <a:ext cx="2314575" cy="6627905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39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496555"/>
            <a:ext cx="3943350" cy="1802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2482765"/>
            <a:ext cx="3943350" cy="59176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8644344"/>
            <a:ext cx="154305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5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2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300" indent="-114300" algn="l" defTabSz="4572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09F29B9-C6DA-4B28-8A4E-B68DB7E369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8421116"/>
              </p:ext>
            </p:extLst>
          </p:nvPr>
        </p:nvGraphicFramePr>
        <p:xfrm>
          <a:off x="59277" y="523701"/>
          <a:ext cx="4103208" cy="1136017"/>
        </p:xfrm>
        <a:graphic>
          <a:graphicData uri="http://schemas.openxmlformats.org/drawingml/2006/table">
            <a:tbl>
              <a:tblPr firstRow="1" firstCol="1" bandRow="1"/>
              <a:tblGrid>
                <a:gridCol w="683868">
                  <a:extLst>
                    <a:ext uri="{9D8B030D-6E8A-4147-A177-3AD203B41FA5}">
                      <a16:colId xmlns:a16="http://schemas.microsoft.com/office/drawing/2014/main" val="2247656971"/>
                    </a:ext>
                  </a:extLst>
                </a:gridCol>
                <a:gridCol w="683868">
                  <a:extLst>
                    <a:ext uri="{9D8B030D-6E8A-4147-A177-3AD203B41FA5}">
                      <a16:colId xmlns:a16="http://schemas.microsoft.com/office/drawing/2014/main" val="3919651169"/>
                    </a:ext>
                  </a:extLst>
                </a:gridCol>
                <a:gridCol w="683868">
                  <a:extLst>
                    <a:ext uri="{9D8B030D-6E8A-4147-A177-3AD203B41FA5}">
                      <a16:colId xmlns:a16="http://schemas.microsoft.com/office/drawing/2014/main" val="3336596670"/>
                    </a:ext>
                  </a:extLst>
                </a:gridCol>
                <a:gridCol w="683868">
                  <a:extLst>
                    <a:ext uri="{9D8B030D-6E8A-4147-A177-3AD203B41FA5}">
                      <a16:colId xmlns:a16="http://schemas.microsoft.com/office/drawing/2014/main" val="1403541771"/>
                    </a:ext>
                  </a:extLst>
                </a:gridCol>
                <a:gridCol w="683868">
                  <a:extLst>
                    <a:ext uri="{9D8B030D-6E8A-4147-A177-3AD203B41FA5}">
                      <a16:colId xmlns:a16="http://schemas.microsoft.com/office/drawing/2014/main" val="2428581129"/>
                    </a:ext>
                  </a:extLst>
                </a:gridCol>
                <a:gridCol w="683868">
                  <a:extLst>
                    <a:ext uri="{9D8B030D-6E8A-4147-A177-3AD203B41FA5}">
                      <a16:colId xmlns:a16="http://schemas.microsoft.com/office/drawing/2014/main" val="3074484396"/>
                    </a:ext>
                  </a:extLst>
                </a:gridCol>
              </a:tblGrid>
              <a:tr h="374549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PS-5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core Pre 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CL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core Pr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ime Since Trauma (years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der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 females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893807"/>
                  </a:ext>
                </a:extLst>
              </a:tr>
              <a:tr h="246605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rauma-NF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.83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.6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.75 (16.49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71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9.9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.25 (21.9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8.33%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4802817"/>
                  </a:ext>
                </a:extLst>
              </a:tr>
              <a:tr h="246605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utral-NF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84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.5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.38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1.1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62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.2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66 (10.71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%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982703"/>
                  </a:ext>
                </a:extLst>
              </a:tr>
              <a:tr h="246605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92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.5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.46 (11.2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49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8.89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 </a:t>
                      </a:r>
                    </a:p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8.6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8.46%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608969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89B0A437-5E97-4FBC-9161-AE6A0C6D69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1831255"/>
              </p:ext>
            </p:extLst>
          </p:nvPr>
        </p:nvGraphicFramePr>
        <p:xfrm>
          <a:off x="96672" y="2069007"/>
          <a:ext cx="4296228" cy="2702928"/>
        </p:xfrm>
        <a:graphic>
          <a:graphicData uri="http://schemas.openxmlformats.org/drawingml/2006/table">
            <a:tbl>
              <a:tblPr firstRow="1" firstCol="1" bandRow="1"/>
              <a:tblGrid>
                <a:gridCol w="1391748">
                  <a:extLst>
                    <a:ext uri="{9D8B030D-6E8A-4147-A177-3AD203B41FA5}">
                      <a16:colId xmlns:a16="http://schemas.microsoft.com/office/drawing/2014/main" val="3235765180"/>
                    </a:ext>
                  </a:extLst>
                </a:gridCol>
                <a:gridCol w="880947">
                  <a:extLst>
                    <a:ext uri="{9D8B030D-6E8A-4147-A177-3AD203B41FA5}">
                      <a16:colId xmlns:a16="http://schemas.microsoft.com/office/drawing/2014/main" val="1956736494"/>
                    </a:ext>
                  </a:extLst>
                </a:gridCol>
                <a:gridCol w="1103035">
                  <a:extLst>
                    <a:ext uri="{9D8B030D-6E8A-4147-A177-3AD203B41FA5}">
                      <a16:colId xmlns:a16="http://schemas.microsoft.com/office/drawing/2014/main" val="983907543"/>
                    </a:ext>
                  </a:extLst>
                </a:gridCol>
                <a:gridCol w="920498">
                  <a:extLst>
                    <a:ext uri="{9D8B030D-6E8A-4147-A177-3AD203B41FA5}">
                      <a16:colId xmlns:a16="http://schemas.microsoft.com/office/drawing/2014/main" val="3693821805"/>
                    </a:ext>
                  </a:extLst>
                </a:gridCol>
              </a:tblGrid>
              <a:tr h="379097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rauma-NF</a:t>
                      </a:r>
                    </a:p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=12)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utral-NF</a:t>
                      </a: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=15)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-NF</a:t>
                      </a:r>
                      <a:endParaRPr lang="en-US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=13)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9730241"/>
                  </a:ext>
                </a:extLst>
              </a:tr>
              <a:tr h="304351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sault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90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662402"/>
                  </a:ext>
                </a:extLst>
              </a:tr>
              <a:tr h="298076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r accident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8093130"/>
                  </a:ext>
                </a:extLst>
              </a:tr>
              <a:tr h="237889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bat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8473287"/>
                  </a:ext>
                </a:extLst>
              </a:tr>
              <a:tr h="255340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fe threatening injury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2089749"/>
                  </a:ext>
                </a:extLst>
              </a:tr>
              <a:tr h="263120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peated exposure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2287921"/>
                  </a:ext>
                </a:extLst>
              </a:tr>
              <a:tr h="288453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error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431121"/>
                  </a:ext>
                </a:extLst>
              </a:tr>
              <a:tr h="340409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raumatic grief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1536893"/>
                  </a:ext>
                </a:extLst>
              </a:tr>
              <a:tr h="336193">
                <a:tc>
                  <a:txBody>
                    <a:bodyPr/>
                    <a:lstStyle/>
                    <a:p>
                      <a:pPr algn="l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itness trauma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740581"/>
                  </a:ext>
                </a:extLst>
              </a:tr>
            </a:tbl>
          </a:graphicData>
        </a:graphic>
      </p:graphicFrame>
      <p:sp>
        <p:nvSpPr>
          <p:cNvPr id="7" name="Rectangle 3">
            <a:extLst>
              <a:ext uri="{FF2B5EF4-FFF2-40B4-BE49-F238E27FC236}">
                <a16:creationId xmlns:a16="http://schemas.microsoft.com/office/drawing/2014/main" id="{6E0D5C76-40D8-4796-8789-F4E78E18BC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42323" y="109163"/>
            <a:ext cx="3410857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he-IL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a. Demographic Characteristics</a:t>
            </a:r>
            <a:endParaRPr kumimoji="0" lang="en-US" altLang="he-IL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D9F7FAB-4957-4E8D-95AB-C42392777C90}"/>
              </a:ext>
            </a:extLst>
          </p:cNvPr>
          <p:cNvSpPr/>
          <p:nvPr/>
        </p:nvSpPr>
        <p:spPr>
          <a:xfrm>
            <a:off x="-42323" y="1792008"/>
            <a:ext cx="25652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he-IL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b. Trauma Type by Group </a:t>
            </a:r>
            <a:endParaRPr lang="en-US" alt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7F4F98-9820-4901-9CDA-26265954C0A4}"/>
              </a:ext>
            </a:extLst>
          </p:cNvPr>
          <p:cNvSpPr txBox="1"/>
          <p:nvPr/>
        </p:nvSpPr>
        <p:spPr>
          <a:xfrm>
            <a:off x="59277" y="4818101"/>
            <a:ext cx="4296229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altLang="he-IL" sz="8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.a. </a:t>
            </a:r>
            <a:r>
              <a:rPr lang="en-US" altLang="he-IL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mographic Characteristics.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No differences were found between groups in baseline characteristics (CAPS-5, PCL, Time Since Trauma Age and Gender (see Supplementary Methods for statistical analysis)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 Type by Group.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F86223B-C640-44D3-8A37-2128B68DD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" y="5443380"/>
            <a:ext cx="451272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he-IL" sz="12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sociations between AmygEFP Learning, Clinical Improvement and amygdala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NF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hange</a:t>
            </a:r>
            <a:endParaRPr kumimoji="0" lang="en-US" altLang="he-IL" sz="12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59815129-BE0C-480C-AF31-70E034225A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1749112"/>
              </p:ext>
            </p:extLst>
          </p:nvPr>
        </p:nvGraphicFramePr>
        <p:xfrm>
          <a:off x="116723" y="6068659"/>
          <a:ext cx="4397829" cy="1852290"/>
        </p:xfrm>
        <a:graphic>
          <a:graphicData uri="http://schemas.openxmlformats.org/drawingml/2006/table">
            <a:tbl>
              <a:tblPr firstRow="1" firstCol="1" bandRow="1"/>
              <a:tblGrid>
                <a:gridCol w="1766654">
                  <a:extLst>
                    <a:ext uri="{9D8B030D-6E8A-4147-A177-3AD203B41FA5}">
                      <a16:colId xmlns:a16="http://schemas.microsoft.com/office/drawing/2014/main" val="1954380353"/>
                    </a:ext>
                  </a:extLst>
                </a:gridCol>
                <a:gridCol w="854370">
                  <a:extLst>
                    <a:ext uri="{9D8B030D-6E8A-4147-A177-3AD203B41FA5}">
                      <a16:colId xmlns:a16="http://schemas.microsoft.com/office/drawing/2014/main" val="3006691959"/>
                    </a:ext>
                  </a:extLst>
                </a:gridCol>
                <a:gridCol w="930793">
                  <a:extLst>
                    <a:ext uri="{9D8B030D-6E8A-4147-A177-3AD203B41FA5}">
                      <a16:colId xmlns:a16="http://schemas.microsoft.com/office/drawing/2014/main" val="2463412697"/>
                    </a:ext>
                  </a:extLst>
                </a:gridCol>
                <a:gridCol w="846012">
                  <a:extLst>
                    <a:ext uri="{9D8B030D-6E8A-4147-A177-3AD203B41FA5}">
                      <a16:colId xmlns:a16="http://schemas.microsoft.com/office/drawing/2014/main" val="1552048553"/>
                    </a:ext>
                  </a:extLst>
                </a:gridCol>
              </a:tblGrid>
              <a:tr h="345197"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asure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7249384"/>
                  </a:ext>
                </a:extLst>
              </a:tr>
              <a:tr h="350383"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) Average AmygEFP NF down regulation success</a:t>
                      </a:r>
                    </a:p>
                    <a:p>
                      <a:pPr marL="0"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__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08097939"/>
                  </a:ext>
                </a:extLst>
              </a:tr>
              <a:tr h="354065">
                <a:tc>
                  <a:txBody>
                    <a:bodyPr/>
                    <a:lstStyle/>
                    <a:p>
                      <a:pPr marL="0"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) CAPS-5 total score decrease following intervention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.09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37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__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8283791"/>
                  </a:ext>
                </a:extLst>
              </a:tr>
              <a:tr h="39363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) PCL total score decrease following intervention </a:t>
                      </a:r>
                    </a:p>
                    <a:p>
                      <a:pPr marL="0"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.02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47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59 **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008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__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8096605"/>
                  </a:ext>
                </a:extLst>
              </a:tr>
              <a:tr h="39363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) fMRI-NF down-regulation decrease following intervention </a:t>
                      </a:r>
                    </a:p>
                    <a:p>
                      <a:pPr marL="0"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.48 *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02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.15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28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.306</a:t>
                      </a:r>
                    </a:p>
                    <a:p>
                      <a:pPr marL="0" marR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p=.12)</a:t>
                      </a:r>
                    </a:p>
                  </a:txBody>
                  <a:tcPr marL="68580" marR="6858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174115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DA9C702D-24A5-4DDC-A49A-9BD7BA3215BF}"/>
              </a:ext>
            </a:extLst>
          </p:cNvPr>
          <p:cNvSpPr/>
          <p:nvPr/>
        </p:nvSpPr>
        <p:spPr>
          <a:xfrm>
            <a:off x="57447" y="7920949"/>
            <a:ext cx="43978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</a:t>
            </a:r>
            <a:r>
              <a:rPr lang="en-US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AmygEFP Learning ,Clinical Improvement and amygdala </a:t>
            </a:r>
            <a:r>
              <a:rPr lang="en-US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tNF</a:t>
            </a:r>
            <a:r>
              <a:rPr lang="en-US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hange Associations.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artial correlation controlling for age, gender and time since trauma (n=20, df=14). Correlation is significant at * p&lt;.05, ** p&lt;.01 </a:t>
            </a:r>
            <a:endParaRPr lang="en-US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9442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99</TotalTime>
  <Words>337</Words>
  <Application>Microsoft Office PowerPoint</Application>
  <PresentationFormat>Custom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Fruchtman</dc:creator>
  <cp:lastModifiedBy>Tom Fruchtman</cp:lastModifiedBy>
  <cp:revision>437</cp:revision>
  <dcterms:created xsi:type="dcterms:W3CDTF">2020-05-29T12:31:49Z</dcterms:created>
  <dcterms:modified xsi:type="dcterms:W3CDTF">2021-05-21T08:01:15Z</dcterms:modified>
</cp:coreProperties>
</file>